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1039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BFEFF"/>
    <a:srgbClr val="F89645"/>
    <a:srgbClr val="9BBC59"/>
    <a:srgbClr val="D5287A"/>
    <a:srgbClr val="4545D3"/>
    <a:srgbClr val="FF8000"/>
    <a:srgbClr val="F79646"/>
    <a:srgbClr val="9BBB59"/>
    <a:srgbClr val="329966"/>
    <a:srgbClr val="41B08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846" autoAdjust="0"/>
    <p:restoredTop sz="96327" autoAdjust="0"/>
  </p:normalViewPr>
  <p:slideViewPr>
    <p:cSldViewPr snapToGrid="0">
      <p:cViewPr varScale="1">
        <p:scale>
          <a:sx n="131" d="100"/>
          <a:sy n="131" d="100"/>
        </p:scale>
        <p:origin x="520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9" d="100"/>
        <a:sy n="149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C3E76F-C128-4FBA-A154-09D0DA14EBD2}" type="datetimeFigureOut">
              <a:rPr lang="fr-FR" smtClean="0"/>
              <a:t>10/12/202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D722C8-87B4-4954-87BD-4F94D5FDB0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10536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C7A90-E868-4D0C-BB3B-40728C122F0C}" type="datetimeFigureOut">
              <a:rPr lang="fr-FR" smtClean="0"/>
              <a:t>10/12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E6A00-0C0E-4E36-A228-E1B376AB76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4628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C7A90-E868-4D0C-BB3B-40728C122F0C}" type="datetimeFigureOut">
              <a:rPr lang="fr-FR" smtClean="0"/>
              <a:t>10/12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E6A00-0C0E-4E36-A228-E1B376AB76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82203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C7A90-E868-4D0C-BB3B-40728C122F0C}" type="datetimeFigureOut">
              <a:rPr lang="fr-FR" smtClean="0"/>
              <a:t>10/12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E6A00-0C0E-4E36-A228-E1B376AB76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0679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C7A90-E868-4D0C-BB3B-40728C122F0C}" type="datetimeFigureOut">
              <a:rPr lang="fr-FR" smtClean="0"/>
              <a:t>10/12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E6A00-0C0E-4E36-A228-E1B376AB76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968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C7A90-E868-4D0C-BB3B-40728C122F0C}" type="datetimeFigureOut">
              <a:rPr lang="fr-FR" smtClean="0"/>
              <a:t>10/12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E6A00-0C0E-4E36-A228-E1B376AB76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1327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C7A90-E868-4D0C-BB3B-40728C122F0C}" type="datetimeFigureOut">
              <a:rPr lang="fr-FR" smtClean="0"/>
              <a:t>10/12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E6A00-0C0E-4E36-A228-E1B376AB76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14751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C7A90-E868-4D0C-BB3B-40728C122F0C}" type="datetimeFigureOut">
              <a:rPr lang="fr-FR" smtClean="0"/>
              <a:t>10/12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E6A00-0C0E-4E36-A228-E1B376AB76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5148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C7A90-E868-4D0C-BB3B-40728C122F0C}" type="datetimeFigureOut">
              <a:rPr lang="fr-FR" smtClean="0"/>
              <a:t>10/12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E6A00-0C0E-4E36-A228-E1B376AB76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9535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C7A90-E868-4D0C-BB3B-40728C122F0C}" type="datetimeFigureOut">
              <a:rPr lang="fr-FR" smtClean="0"/>
              <a:t>10/12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E6A00-0C0E-4E36-A228-E1B376AB76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9490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C7A90-E868-4D0C-BB3B-40728C122F0C}" type="datetimeFigureOut">
              <a:rPr lang="fr-FR" smtClean="0"/>
              <a:t>10/12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E6A00-0C0E-4E36-A228-E1B376AB76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19358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C7A90-E868-4D0C-BB3B-40728C122F0C}" type="datetimeFigureOut">
              <a:rPr lang="fr-FR" smtClean="0"/>
              <a:t>10/12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E6A00-0C0E-4E36-A228-E1B376AB76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4195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C7A90-E868-4D0C-BB3B-40728C122F0C}" type="datetimeFigureOut">
              <a:rPr lang="fr-FR" smtClean="0"/>
              <a:t>10/12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4E6A00-0C0E-4E36-A228-E1B376AB76A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0713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CF929CE0-E993-404F-BA34-7EF8155781F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8397"/>
          <a:stretch/>
        </p:blipFill>
        <p:spPr>
          <a:xfrm>
            <a:off x="288141" y="211014"/>
            <a:ext cx="6755754" cy="8440495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2C04AAC0-D6DC-54C5-449F-9CCC62C5A5F6}"/>
              </a:ext>
            </a:extLst>
          </p:cNvPr>
          <p:cNvSpPr txBox="1"/>
          <p:nvPr/>
        </p:nvSpPr>
        <p:spPr>
          <a:xfrm>
            <a:off x="3934876" y="7706173"/>
            <a:ext cx="2398643" cy="7540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endParaRPr lang="fr-FR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fr-FR" sz="1200" dirty="0" err="1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Residues</a:t>
            </a:r>
            <a:r>
              <a:rPr lang="fr-FR" sz="12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 of the binding </a:t>
            </a:r>
            <a:r>
              <a:rPr lang="fr-FR" sz="1200" dirty="0" err="1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pocket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fr-FR" sz="1200" dirty="0" err="1"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Residues</a:t>
            </a:r>
            <a:r>
              <a:rPr lang="fr-FR" sz="1200" dirty="0"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 of the active site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fr-FR" sz="1200" u="heavy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idues</a:t>
            </a:r>
            <a:r>
              <a:rPr lang="fr-FR" sz="1200" u="heavy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the dimer interface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5D43E3BB-8EF9-B13C-C4F8-D449153D70E5}"/>
              </a:ext>
            </a:extLst>
          </p:cNvPr>
          <p:cNvSpPr txBox="1"/>
          <p:nvPr/>
        </p:nvSpPr>
        <p:spPr>
          <a:xfrm>
            <a:off x="73732" y="8651509"/>
            <a:ext cx="718457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kern="100" noProof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5. </a:t>
            </a:r>
            <a:r>
              <a:rPr lang="en-US" sz="1200" kern="100" noProof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quence alignment of Slr0605 with representative GHR class GSTs. </a:t>
            </a:r>
            <a:r>
              <a:rPr lang="en-US" sz="1200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t was performed with Clustal Omega </a:t>
            </a:r>
            <a:r>
              <a:rPr lang="en-US" sz="1200" kern="100" noProof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gram</a:t>
            </a:r>
            <a:r>
              <a:rPr lang="en-US" sz="1200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NCBI accession numbers are bracketed: </a:t>
            </a:r>
            <a:r>
              <a:rPr lang="en-US" sz="1200" i="1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abidopsis thaliana</a:t>
            </a:r>
            <a:r>
              <a:rPr lang="en-US" sz="1200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tECM4a (NP_001190472.1), </a:t>
            </a:r>
            <a:r>
              <a:rPr lang="en-US" sz="1200" i="1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pulus trichocarpa</a:t>
            </a:r>
            <a:r>
              <a:rPr lang="en-US" sz="1200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t-GHR1 and Pt-GHR2 (XP_002322375.4 and XP_002320605.4); </a:t>
            </a:r>
            <a:r>
              <a:rPr lang="en-US" sz="1200" i="1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scherichia coli</a:t>
            </a:r>
            <a:r>
              <a:rPr lang="en-US" sz="1200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cYqjG (UMQ10289.1); </a:t>
            </a:r>
            <a:r>
              <a:rPr lang="en-US" sz="1200" i="1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hingobium chlorophenolicum</a:t>
            </a:r>
            <a:r>
              <a:rPr lang="en-US" sz="1200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cpF (WP_013849831.1); </a:t>
            </a:r>
            <a:r>
              <a:rPr lang="en-US" sz="1200" i="1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seudomonas putida </a:t>
            </a:r>
            <a:r>
              <a:rPr lang="en-US" sz="1200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T2440</a:t>
            </a:r>
            <a:r>
              <a:rPr lang="en-US" sz="1200" i="1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AN69592.1); </a:t>
            </a:r>
            <a:r>
              <a:rPr lang="en-US" sz="1200" i="1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atrialba magadii</a:t>
            </a:r>
            <a:r>
              <a:rPr lang="en-US" sz="1200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mGHR (WP_004217051.1) and </a:t>
            </a:r>
            <a:r>
              <a:rPr lang="en-US" sz="1200" i="1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nechocystis</a:t>
            </a:r>
            <a:r>
              <a:rPr lang="en-US" sz="1200" kern="100" noProof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CC 6803 slr0605 (WP_010874352.1). The secondary structures (alpha helices and beta sheets) of the proteins EcYqjG and PcpF are displayed above the aligned residues. The level of homology is represented by a blue gradient, with dark-blue highlighting strictly conserved amino-acid residues. Residues forming the dimer interface are boxed, while those involved in the catalytic site and GSH binding pocket are indicated in red and yellow, respectively. </a:t>
            </a:r>
            <a:endParaRPr lang="en-US" sz="1200" kern="100" noProof="1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312455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607</TotalTime>
  <Words>172</Words>
  <Application>Microsoft Macintosh PowerPoint</Application>
  <PresentationFormat>Personnalisé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NNY MARCEAU</dc:creator>
  <cp:lastModifiedBy>Franck Chauvat</cp:lastModifiedBy>
  <cp:revision>564</cp:revision>
  <dcterms:created xsi:type="dcterms:W3CDTF">2024-03-03T08:56:33Z</dcterms:created>
  <dcterms:modified xsi:type="dcterms:W3CDTF">2024-12-10T16:11:09Z</dcterms:modified>
</cp:coreProperties>
</file>